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75" r:id="rId2"/>
    <p:sldId id="286" r:id="rId3"/>
    <p:sldId id="889" r:id="rId4"/>
    <p:sldId id="886" r:id="rId5"/>
    <p:sldId id="892" r:id="rId6"/>
    <p:sldId id="89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4663"/>
  </p:normalViewPr>
  <p:slideViewPr>
    <p:cSldViewPr snapToGrid="0" snapToObjects="1">
      <p:cViewPr varScale="1">
        <p:scale>
          <a:sx n="121" d="100"/>
          <a:sy n="121" d="100"/>
        </p:scale>
        <p:origin x="20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acobschulman/Documents/The_Folder/School/Medical_Biophysics/Research/Data/Clinical/Clinical/Sta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acobschulman/Documents/The_Folder/School/Medical_Biophysics/Research/Data/Clinical/Clinical/Sta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acobschulman/Documents/The_Folder/School/Medical_Biophysics/Research/Data/Simulations/SIandR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usceptibility_AIF_VOF!$Q$4</c:f>
              <c:strCache>
                <c:ptCount val="1"/>
                <c:pt idx="0">
                  <c:v>∫Arterial to ∫Venous Ratio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>
                  <a:alpha val="0"/>
                </a:srgbClr>
              </a:solidFill>
              <a:ln w="9525">
                <a:solidFill>
                  <a:srgbClr val="C00000">
                    <a:alpha val="0"/>
                  </a:srgbClr>
                </a:solidFill>
              </a:ln>
              <a:effectLst/>
            </c:spPr>
          </c:marker>
          <c:xVal>
            <c:numRef>
              <c:f>Susceptibility_AIF_VOF!$N$5:$N$32</c:f>
              <c:numCache>
                <c:formatCode>General</c:formatCode>
                <c:ptCount val="28"/>
                <c:pt idx="0">
                  <c:v>2.5999999999999999E-3</c:v>
                </c:pt>
                <c:pt idx="1">
                  <c:v>5.1999999999999998E-3</c:v>
                </c:pt>
                <c:pt idx="2">
                  <c:v>7.7999999999999996E-3</c:v>
                </c:pt>
                <c:pt idx="3">
                  <c:v>1.04E-2</c:v>
                </c:pt>
                <c:pt idx="4">
                  <c:v>1.2999999999999999E-2</c:v>
                </c:pt>
                <c:pt idx="5">
                  <c:v>1.5599999999999999E-2</c:v>
                </c:pt>
                <c:pt idx="6">
                  <c:v>1.8199999999999997E-2</c:v>
                </c:pt>
                <c:pt idx="7">
                  <c:v>2.0799999999999999E-2</c:v>
                </c:pt>
                <c:pt idx="8">
                  <c:v>2.3400000000000001E-2</c:v>
                </c:pt>
                <c:pt idx="9">
                  <c:v>2.5999999999999999E-2</c:v>
                </c:pt>
                <c:pt idx="10">
                  <c:v>2.86E-2</c:v>
                </c:pt>
                <c:pt idx="11">
                  <c:v>3.1199999999999999E-2</c:v>
                </c:pt>
                <c:pt idx="12">
                  <c:v>3.3799999999999997E-2</c:v>
                </c:pt>
                <c:pt idx="13">
                  <c:v>3.6399999999999995E-2</c:v>
                </c:pt>
                <c:pt idx="14">
                  <c:v>3.9E-2</c:v>
                </c:pt>
                <c:pt idx="15">
                  <c:v>4.1599999999999998E-2</c:v>
                </c:pt>
                <c:pt idx="16">
                  <c:v>4.4199999999999996E-2</c:v>
                </c:pt>
                <c:pt idx="17">
                  <c:v>4.6800000000000001E-2</c:v>
                </c:pt>
                <c:pt idx="18">
                  <c:v>4.9399999999999993E-2</c:v>
                </c:pt>
                <c:pt idx="19">
                  <c:v>5.1999999999999998E-2</c:v>
                </c:pt>
                <c:pt idx="20">
                  <c:v>7.8E-2</c:v>
                </c:pt>
                <c:pt idx="21">
                  <c:v>0.104</c:v>
                </c:pt>
                <c:pt idx="22">
                  <c:v>0.13</c:v>
                </c:pt>
                <c:pt idx="23">
                  <c:v>0.156</c:v>
                </c:pt>
                <c:pt idx="24">
                  <c:v>0.182</c:v>
                </c:pt>
                <c:pt idx="25">
                  <c:v>0.20799999999999999</c:v>
                </c:pt>
                <c:pt idx="26">
                  <c:v>0.23399999999999999</c:v>
                </c:pt>
                <c:pt idx="27">
                  <c:v>0.26</c:v>
                </c:pt>
              </c:numCache>
            </c:numRef>
          </c:xVal>
          <c:yVal>
            <c:numRef>
              <c:f>Susceptibility_AIF_VOF!$Q$5:$Q$32</c:f>
              <c:numCache>
                <c:formatCode>General</c:formatCode>
                <c:ptCount val="28"/>
                <c:pt idx="0">
                  <c:v>2.43286868215692E-2</c:v>
                </c:pt>
                <c:pt idx="1">
                  <c:v>4.46354456921252E-2</c:v>
                </c:pt>
                <c:pt idx="2">
                  <c:v>6.4655472596475305E-2</c:v>
                </c:pt>
                <c:pt idx="3">
                  <c:v>8.4371413863470496E-2</c:v>
                </c:pt>
                <c:pt idx="4">
                  <c:v>0.103774055495701</c:v>
                </c:pt>
                <c:pt idx="5">
                  <c:v>0.122859571649897</c:v>
                </c:pt>
                <c:pt idx="6">
                  <c:v>0.14162771653748699</c:v>
                </c:pt>
                <c:pt idx="7">
                  <c:v>0.16008062549990901</c:v>
                </c:pt>
                <c:pt idx="8">
                  <c:v>0.178222012810553</c:v>
                </c:pt>
                <c:pt idx="9">
                  <c:v>0.196056630174197</c:v>
                </c:pt>
                <c:pt idx="10">
                  <c:v>0.21358989812721699</c:v>
                </c:pt>
                <c:pt idx="11">
                  <c:v>0.230827653192862</c:v>
                </c:pt>
                <c:pt idx="12">
                  <c:v>0.247775973269488</c:v>
                </c:pt>
                <c:pt idx="13">
                  <c:v>0.26444105639258703</c:v>
                </c:pt>
                <c:pt idx="14">
                  <c:v>0.280829136249933</c:v>
                </c:pt>
                <c:pt idx="15">
                  <c:v>0.29694642323431703</c:v>
                </c:pt>
                <c:pt idx="16">
                  <c:v>0.31279906339536201</c:v>
                </c:pt>
                <c:pt idx="17">
                  <c:v>0.32839311003965899</c:v>
                </c:pt>
                <c:pt idx="18">
                  <c:v>0.34373450433660302</c:v>
                </c:pt>
                <c:pt idx="19">
                  <c:v>0.35882906237989398</c:v>
                </c:pt>
                <c:pt idx="20">
                  <c:v>0.497379774253909</c:v>
                </c:pt>
                <c:pt idx="21">
                  <c:v>0.61663823594258804</c:v>
                </c:pt>
                <c:pt idx="22">
                  <c:v>0.72034875526769204</c:v>
                </c:pt>
                <c:pt idx="23">
                  <c:v>0.811358355019838</c:v>
                </c:pt>
                <c:pt idx="24">
                  <c:v>0.89186255605258202</c:v>
                </c:pt>
                <c:pt idx="25">
                  <c:v>0.96357970238278301</c:v>
                </c:pt>
                <c:pt idx="26">
                  <c:v>1.02787329499063</c:v>
                </c:pt>
                <c:pt idx="27">
                  <c:v>1.08583885549016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BE2-8844-816A-9F29143EB8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0667983"/>
        <c:axId val="261846559"/>
      </c:scatterChart>
      <c:valAx>
        <c:axId val="230667983"/>
        <c:scaling>
          <c:orientation val="minMax"/>
          <c:max val="0.15000000000000002"/>
          <c:min val="1.0000000000000002E-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</a:rPr>
                  <a:t>Peak Susceptibil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1846559"/>
        <c:crosses val="autoZero"/>
        <c:crossBetween val="midCat"/>
      </c:valAx>
      <c:valAx>
        <c:axId val="261846559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  <a:effectLst/>
                  </a:rPr>
                  <a:t>∫∆R</a:t>
                </a:r>
                <a:r>
                  <a:rPr lang="en-US" sz="1800" b="1" baseline="-25000" dirty="0">
                    <a:solidFill>
                      <a:schemeClr val="tx1"/>
                    </a:solidFill>
                    <a:effectLst/>
                  </a:rPr>
                  <a:t>2, Artery</a:t>
                </a:r>
                <a:r>
                  <a:rPr lang="en-US" sz="1800" b="1" dirty="0">
                    <a:solidFill>
                      <a:schemeClr val="tx1"/>
                    </a:solidFill>
                    <a:effectLst/>
                  </a:rPr>
                  <a:t>* to ∫∆R</a:t>
                </a:r>
                <a:r>
                  <a:rPr lang="en-US" sz="1800" b="1" baseline="-25000" dirty="0">
                    <a:solidFill>
                      <a:schemeClr val="tx1"/>
                    </a:solidFill>
                    <a:effectLst/>
                  </a:rPr>
                  <a:t>2, Vein</a:t>
                </a:r>
                <a:r>
                  <a:rPr lang="en-US" sz="1800" b="1" dirty="0">
                    <a:solidFill>
                      <a:schemeClr val="tx1"/>
                    </a:solidFill>
                    <a:effectLst/>
                  </a:rPr>
                  <a:t>* Ratio </a:t>
                </a:r>
                <a:endParaRPr lang="en-CA" b="1" dirty="0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6.2369705020761251E-3"/>
              <c:y val="7.560170696730561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0667983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usceptibility_AIF_VOF!$AA$4</c:f>
              <c:strCache>
                <c:ptCount val="1"/>
                <c:pt idx="0">
                  <c:v>CBV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>
                  <a:alpha val="0"/>
                </a:srgbClr>
              </a:solidFill>
              <a:ln w="9525">
                <a:solidFill>
                  <a:srgbClr val="C00000">
                    <a:alpha val="0"/>
                  </a:srgbClr>
                </a:solidFill>
              </a:ln>
              <a:effectLst/>
            </c:spPr>
          </c:marker>
          <c:xVal>
            <c:numRef>
              <c:f>Susceptibility_AIF_VOF!$X$5:$X$32</c:f>
              <c:numCache>
                <c:formatCode>General</c:formatCode>
                <c:ptCount val="28"/>
                <c:pt idx="0">
                  <c:v>2.5999999999999999E-3</c:v>
                </c:pt>
                <c:pt idx="1">
                  <c:v>5.1999999999999998E-3</c:v>
                </c:pt>
                <c:pt idx="2">
                  <c:v>7.7999999999999996E-3</c:v>
                </c:pt>
                <c:pt idx="3">
                  <c:v>1.04E-2</c:v>
                </c:pt>
                <c:pt idx="4">
                  <c:v>1.2999999999999999E-2</c:v>
                </c:pt>
                <c:pt idx="5">
                  <c:v>1.5599999999999999E-2</c:v>
                </c:pt>
                <c:pt idx="6">
                  <c:v>1.8199999999999997E-2</c:v>
                </c:pt>
                <c:pt idx="7">
                  <c:v>2.0799999999999999E-2</c:v>
                </c:pt>
                <c:pt idx="8">
                  <c:v>2.3400000000000001E-2</c:v>
                </c:pt>
                <c:pt idx="9">
                  <c:v>2.5999999999999999E-2</c:v>
                </c:pt>
                <c:pt idx="10">
                  <c:v>2.86E-2</c:v>
                </c:pt>
                <c:pt idx="11">
                  <c:v>3.1199999999999999E-2</c:v>
                </c:pt>
                <c:pt idx="12">
                  <c:v>3.3799999999999997E-2</c:v>
                </c:pt>
                <c:pt idx="13">
                  <c:v>3.6399999999999995E-2</c:v>
                </c:pt>
                <c:pt idx="14">
                  <c:v>3.9E-2</c:v>
                </c:pt>
                <c:pt idx="15">
                  <c:v>4.1599999999999998E-2</c:v>
                </c:pt>
                <c:pt idx="16">
                  <c:v>4.4199999999999996E-2</c:v>
                </c:pt>
                <c:pt idx="17">
                  <c:v>4.6800000000000001E-2</c:v>
                </c:pt>
                <c:pt idx="18">
                  <c:v>4.9399999999999993E-2</c:v>
                </c:pt>
                <c:pt idx="19">
                  <c:v>5.1999999999999998E-2</c:v>
                </c:pt>
                <c:pt idx="20">
                  <c:v>7.8E-2</c:v>
                </c:pt>
                <c:pt idx="21">
                  <c:v>0.104</c:v>
                </c:pt>
                <c:pt idx="22">
                  <c:v>0.13</c:v>
                </c:pt>
                <c:pt idx="23">
                  <c:v>0.156</c:v>
                </c:pt>
                <c:pt idx="24">
                  <c:v>0.182</c:v>
                </c:pt>
                <c:pt idx="25">
                  <c:v>0.20799999999999999</c:v>
                </c:pt>
                <c:pt idx="26">
                  <c:v>0.23399999999999999</c:v>
                </c:pt>
                <c:pt idx="27">
                  <c:v>0.26</c:v>
                </c:pt>
              </c:numCache>
            </c:numRef>
          </c:xVal>
          <c:yVal>
            <c:numRef>
              <c:f>Susceptibility_AIF_VOF!$AA$5:$AA$32</c:f>
              <c:numCache>
                <c:formatCode>General</c:formatCode>
                <c:ptCount val="28"/>
                <c:pt idx="0">
                  <c:v>5.0545</c:v>
                </c:pt>
                <c:pt idx="1">
                  <c:v>2.7311999999999999</c:v>
                </c:pt>
                <c:pt idx="2">
                  <c:v>1.8693</c:v>
                </c:pt>
                <c:pt idx="3">
                  <c:v>1.4201999999999999</c:v>
                </c:pt>
                <c:pt idx="4">
                  <c:v>1.1449</c:v>
                </c:pt>
                <c:pt idx="5">
                  <c:v>0.95879999999999999</c:v>
                </c:pt>
                <c:pt idx="6">
                  <c:v>0.82479999999999998</c:v>
                </c:pt>
                <c:pt idx="7">
                  <c:v>0.72360000000000002</c:v>
                </c:pt>
                <c:pt idx="8">
                  <c:v>0.64449999999999996</c:v>
                </c:pt>
                <c:pt idx="9">
                  <c:v>0.58099999999999996</c:v>
                </c:pt>
                <c:pt idx="10">
                  <c:v>0.52890000000000004</c:v>
                </c:pt>
                <c:pt idx="11">
                  <c:v>0.4854</c:v>
                </c:pt>
                <c:pt idx="12">
                  <c:v>0.44850000000000001</c:v>
                </c:pt>
                <c:pt idx="13">
                  <c:v>0.4168</c:v>
                </c:pt>
                <c:pt idx="14">
                  <c:v>0.38929999999999998</c:v>
                </c:pt>
                <c:pt idx="15">
                  <c:v>0.36520000000000002</c:v>
                </c:pt>
                <c:pt idx="16">
                  <c:v>0.34389999999999998</c:v>
                </c:pt>
                <c:pt idx="17">
                  <c:v>0.32500000000000001</c:v>
                </c:pt>
                <c:pt idx="18">
                  <c:v>0.308</c:v>
                </c:pt>
                <c:pt idx="19">
                  <c:v>0.29270000000000002</c:v>
                </c:pt>
                <c:pt idx="20">
                  <c:v>0.1953</c:v>
                </c:pt>
                <c:pt idx="21">
                  <c:v>0.1462</c:v>
                </c:pt>
                <c:pt idx="22">
                  <c:v>0.1166</c:v>
                </c:pt>
                <c:pt idx="23">
                  <c:v>9.6699999999999994E-2</c:v>
                </c:pt>
                <c:pt idx="24">
                  <c:v>8.2500000000000004E-2</c:v>
                </c:pt>
                <c:pt idx="25">
                  <c:v>7.1800000000000003E-2</c:v>
                </c:pt>
                <c:pt idx="26">
                  <c:v>6.3600000000000004E-2</c:v>
                </c:pt>
                <c:pt idx="27">
                  <c:v>5.70000000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F63-C246-B016-3E68DAE842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833791"/>
        <c:axId val="233835439"/>
      </c:scatterChart>
      <c:valAx>
        <c:axId val="233833791"/>
        <c:scaling>
          <c:orientation val="minMax"/>
          <c:max val="0.15000000000000002"/>
          <c:min val="1.0000000000000002E-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i="0" baseline="0" dirty="0">
                    <a:solidFill>
                      <a:schemeClr val="tx1"/>
                    </a:solidFill>
                    <a:effectLst/>
                  </a:rPr>
                  <a:t>Peak Susceptibility</a:t>
                </a:r>
                <a:endParaRPr lang="en-CA" b="1" dirty="0">
                  <a:solidFill>
                    <a:schemeClr val="tx1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3835439"/>
        <c:crosses val="autoZero"/>
        <c:crossBetween val="midCat"/>
      </c:valAx>
      <c:valAx>
        <c:axId val="233835439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i="1" dirty="0">
                    <a:solidFill>
                      <a:schemeClr val="tx1"/>
                    </a:solidFill>
                  </a:rPr>
                  <a:t>rCBV</a:t>
                </a:r>
                <a:r>
                  <a:rPr lang="en-US" sz="1800" b="1" dirty="0">
                    <a:solidFill>
                      <a:schemeClr val="tx1"/>
                    </a:solidFill>
                  </a:rPr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3833791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D$6</c:f>
              <c:strCache>
                <c:ptCount val="1"/>
                <c:pt idx="0">
                  <c:v>∆Sdohb/∆Sg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2D2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5EA-D547-B422-E6D394282267}"/>
              </c:ext>
            </c:extLst>
          </c:dPt>
          <c:dPt>
            <c:idx val="1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5EA-D547-B422-E6D39428226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5EA-D547-B422-E6D39428226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5EA-D547-B422-E6D394282267}"/>
              </c:ext>
            </c:extLst>
          </c:dPt>
          <c:cat>
            <c:strRef>
              <c:f>Sheet2!$A$9:$A$12</c:f>
              <c:strCache>
                <c:ptCount val="4"/>
                <c:pt idx="0">
                  <c:v>Artery (CBV = 90%))</c:v>
                </c:pt>
                <c:pt idx="1">
                  <c:v>Vein (CBV = 90%))</c:v>
                </c:pt>
                <c:pt idx="2">
                  <c:v>GM (CBV = 4%)</c:v>
                </c:pt>
                <c:pt idx="3">
                  <c:v>WM (CBV = 2%)</c:v>
                </c:pt>
              </c:strCache>
            </c:strRef>
          </c:cat>
          <c:val>
            <c:numRef>
              <c:f>Sheet2!$D$9:$D$12</c:f>
              <c:numCache>
                <c:formatCode>General</c:formatCode>
                <c:ptCount val="4"/>
                <c:pt idx="0">
                  <c:v>0.16820000000000002</c:v>
                </c:pt>
                <c:pt idx="1">
                  <c:v>0.50749999999999995</c:v>
                </c:pt>
                <c:pt idx="2">
                  <c:v>0.21628928692125721</c:v>
                </c:pt>
                <c:pt idx="3">
                  <c:v>0.20299812617114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5EA-D547-B422-E6D3942822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4137680"/>
        <c:axId val="1604139328"/>
      </c:barChart>
      <c:catAx>
        <c:axId val="1604137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4139328"/>
        <c:crosses val="autoZero"/>
        <c:auto val="1"/>
        <c:lblAlgn val="ctr"/>
        <c:lblOffset val="100"/>
        <c:noMultiLvlLbl val="0"/>
      </c:catAx>
      <c:valAx>
        <c:axId val="1604139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4137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C50D6E-59CD-D246-A5FB-EF80FF04298E}" type="datetimeFigureOut">
              <a:rPr lang="en-US" smtClean="0"/>
              <a:t>4/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827ABD-5BE0-AA45-B5E9-69C103BD28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44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29D9EF-12E1-674B-8DB4-F0E64D390D4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64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E35907-1A60-9143-8286-D06FC3DD0E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717273-F906-CE44-AE52-8E26094F79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68B56-FCA2-B740-8027-30049182C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89C0D3-21A4-A146-A8FC-3C7EB9FF6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C8D32-00EA-2A47-80DA-546674344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670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B8A4E5-F6AA-1241-970A-0E8E43724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79F038-4350-F649-953F-3FD594FE54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3953CE-C746-1C4D-B95E-C7ADC9853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44991-B7C6-C943-8AF2-FB5C62F5E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B3E4A-01FC-FF47-82B4-3C6F9D358A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976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86AF90-10A3-204F-BE20-4E527510A2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DE4195-CB2B-B140-82F0-1A6010D762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324FE-9CB5-4F4E-BCED-AA90D2937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EBCFA-586E-9A45-8297-5C8BD118A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AE267-706D-644C-AB61-31ADDA05E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371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1F6941-0E1E-0744-9CBF-4E8F9C050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C4A63B-8A09-2D42-A90A-ADE6EF91E7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533AD7-29A7-FE4A-8C20-48B580D41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D36DE-B19F-6949-88A5-C0D000328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FB912A-0ACC-9041-A47D-70FE88CFC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05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E2F98-C771-574C-B19B-7207D8CF5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CBCCC4-8CB4-3B43-A497-0B790C360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C82AED-0374-E145-918D-B227D3691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23F4EB-6D18-6947-A9E1-2E6F55250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C9E762-6233-2C46-A3C6-AD5AE8884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59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B3141-4D1E-AA4C-9133-5AFB0E13E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A6DDD3-76A1-AF43-95D4-5CEF311640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4C241F-9805-DD40-9A8D-474B3CC55C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BAFFDE-D705-184A-93E0-AEB2171DE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2C65F1-CA04-AE4F-9FE0-48638C33C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8C0C90-54C3-9B4B-B358-431030023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077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FBE5CB-903C-8146-A328-CF644FA36F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65037E-F228-4D4B-8B3A-3CADCF209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5DCDE5-B604-1448-A90D-EC7D0959BC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658D33-A7E5-714B-A70D-2ACC220B22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E5522F-9017-2548-832A-E8EC0B1908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335F16-ED80-484D-B559-37F9D0436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03ADCA-63A9-2543-92C1-887903585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471B00-951B-7D43-8590-15B5E0EAB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688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93FC2-A174-1642-BAD2-1D4CBC3452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D39358-D00F-A14E-96B0-5E8B10916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F10550-A6A2-1B4E-884D-A04081392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E11018-B0BC-624B-9566-024E87B489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772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819EE61-43CA-2B45-A392-72B664BB8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CD390F-5250-0048-917E-111BA38E63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EB1D70-AAA7-D244-9B64-FDAB178E7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283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6B105F-3099-B848-BFA6-3783F6A6E6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612911-5E7B-7E4F-872F-E8E26BF80D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3184AC-A7D6-E44C-9E7B-0781EA0CD8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46685A-51E2-B54D-97E6-C968EE5CE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A46A36-A7A0-C34A-95CC-13960A566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C12CF3-9E40-AB42-B9EE-2E5B8D585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84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41AE8C-342C-574D-8E90-CCD402CE7A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567CBE-9727-D749-9981-06F7AF6A4D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CD6B7B-BF7D-C947-9E11-EB68CEC780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4BAA25-CB4A-8646-81B8-487B5859E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27DA21-78B2-5C4A-9E8A-008E98908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EFF38F-5AB5-F442-AD67-869D7EA05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35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9D831C-194E-6D41-9690-C38105EC5F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12CDD1-3B20-C749-90CA-6C493E5CF1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FB4605-3D47-6340-9598-68A4D57C93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AB92A-A05A-1848-BC3D-6BAD8A15F9C6}" type="datetimeFigureOut">
              <a:rPr lang="en-US" smtClean="0"/>
              <a:t>4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75ED26-47A3-154B-8639-C686675938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8D5D9E-98DE-424F-9CA5-11811DE74B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650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496F3F2-AB70-9945-94F8-88D59C7F6637}"/>
              </a:ext>
            </a:extLst>
          </p:cNvPr>
          <p:cNvGraphicFramePr>
            <a:graphicFrameLocks noGrp="1"/>
          </p:cNvGraphicFramePr>
          <p:nvPr/>
        </p:nvGraphicFramePr>
        <p:xfrm>
          <a:off x="838197" y="1425096"/>
          <a:ext cx="10515605" cy="40078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33033">
                  <a:extLst>
                    <a:ext uri="{9D8B030D-6E8A-4147-A177-3AD203B41FA5}">
                      <a16:colId xmlns:a16="http://schemas.microsoft.com/office/drawing/2014/main" val="3596140922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690863096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2344398469"/>
                    </a:ext>
                  </a:extLst>
                </a:gridCol>
                <a:gridCol w="803937">
                  <a:extLst>
                    <a:ext uri="{9D8B030D-6E8A-4147-A177-3AD203B41FA5}">
                      <a16:colId xmlns:a16="http://schemas.microsoft.com/office/drawing/2014/main" val="3612842253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3418187972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3251024397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4087616194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2335344806"/>
                    </a:ext>
                  </a:extLst>
                </a:gridCol>
                <a:gridCol w="742726">
                  <a:extLst>
                    <a:ext uri="{9D8B030D-6E8A-4147-A177-3AD203B41FA5}">
                      <a16:colId xmlns:a16="http://schemas.microsoft.com/office/drawing/2014/main" val="747941575"/>
                    </a:ext>
                  </a:extLst>
                </a:gridCol>
                <a:gridCol w="719528">
                  <a:extLst>
                    <a:ext uri="{9D8B030D-6E8A-4147-A177-3AD203B41FA5}">
                      <a16:colId xmlns:a16="http://schemas.microsoft.com/office/drawing/2014/main" val="2556873166"/>
                    </a:ext>
                  </a:extLst>
                </a:gridCol>
                <a:gridCol w="674557">
                  <a:extLst>
                    <a:ext uri="{9D8B030D-6E8A-4147-A177-3AD203B41FA5}">
                      <a16:colId xmlns:a16="http://schemas.microsoft.com/office/drawing/2014/main" val="1331531029"/>
                    </a:ext>
                  </a:extLst>
                </a:gridCol>
                <a:gridCol w="745184">
                  <a:extLst>
                    <a:ext uri="{9D8B030D-6E8A-4147-A177-3AD203B41FA5}">
                      <a16:colId xmlns:a16="http://schemas.microsoft.com/office/drawing/2014/main" val="2477484248"/>
                    </a:ext>
                  </a:extLst>
                </a:gridCol>
                <a:gridCol w="715110">
                  <a:extLst>
                    <a:ext uri="{9D8B030D-6E8A-4147-A177-3AD203B41FA5}">
                      <a16:colId xmlns:a16="http://schemas.microsoft.com/office/drawing/2014/main" val="47674560"/>
                    </a:ext>
                  </a:extLst>
                </a:gridCol>
              </a:tblGrid>
              <a:tr h="544247">
                <a:tc>
                  <a:txBody>
                    <a:bodyPr/>
                    <a:lstStyle/>
                    <a:p>
                      <a:pPr algn="ctr" fontAlgn="t"/>
                      <a:r>
                        <a:rPr lang="en-CA" sz="1500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 </a:t>
                      </a:r>
                      <a:endParaRPr lang="en-CA" sz="1500" b="0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>
                    <a:solidFill>
                      <a:srgbClr val="00206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u="none" strike="noStrike" dirty="0">
                          <a:solidFill>
                            <a:srgbClr val="FF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Gd</a:t>
                      </a:r>
                      <a:endParaRPr lang="en-CA" sz="1400" b="1" i="0" u="none" strike="noStrike" dirty="0">
                        <a:solidFill>
                          <a:srgbClr val="FF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u="none" strike="noStrike" dirty="0">
                          <a:solidFill>
                            <a:srgbClr val="FF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Average dOHb</a:t>
                      </a:r>
                      <a:endParaRPr lang="en-CA" sz="1400" b="1" i="0" u="none" strike="noStrike" dirty="0">
                        <a:solidFill>
                          <a:srgbClr val="FF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Large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High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Medium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High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Small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High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Small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</a:t>
                      </a:r>
                    </a:p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Low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5142482"/>
                  </a:ext>
                </a:extLst>
              </a:tr>
              <a:tr h="325840">
                <a:tc>
                  <a:txBody>
                    <a:bodyPr/>
                    <a:lstStyle/>
                    <a:p>
                      <a:pPr algn="l" fontAlgn="t"/>
                      <a:r>
                        <a:rPr lang="en-CA" sz="150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 </a:t>
                      </a:r>
                      <a:endParaRPr lang="en-CA" sz="1500" b="0" i="0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8662796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∆S (</a:t>
                      </a:r>
                      <a:r>
                        <a:rPr lang="en-CA" sz="1500" b="1" i="0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%</a:t>
                      </a:r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)</a:t>
                      </a: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4.3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3.09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94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.5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4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07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2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6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97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01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4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21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4043289136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5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6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4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.2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4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3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3.22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.95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45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.61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77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.6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3089186545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NR</a:t>
                      </a: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8.59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5.09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9.7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4.5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32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9.26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9.8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7.76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7.04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0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0.17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7.81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3058790698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31.44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6.48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9.16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68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45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37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44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4.9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4.84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3.9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.86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5.71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1594944884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rCBV</a:t>
                      </a:r>
                      <a:r>
                        <a:rPr lang="en-CA" sz="1500" b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 (mL/100g)</a:t>
                      </a:r>
                      <a:endParaRPr lang="en-CA" sz="15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6.8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3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4.4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.2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1.8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97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7.5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65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6.6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5.2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8.7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7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1659702830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1.46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46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25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6.44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1.9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6.18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7.17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39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7.3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5.46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8.53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72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2574445610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rCBF</a:t>
                      </a:r>
                      <a:r>
                        <a:rPr lang="en-CA" sz="1500" b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 (mL/100g/min)</a:t>
                      </a:r>
                      <a:endParaRPr lang="en-CA" sz="15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404.07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32.19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79.94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88.84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44.6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1.01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82.18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98.01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30.25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41.6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10.52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9.2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2997997894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15.7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3.25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41.7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9.59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20.76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64.65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48.98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86.97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64.84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10.99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97.23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7.5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3627099668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MTT</a:t>
                      </a:r>
                      <a:r>
                        <a:rPr lang="en-CA" sz="1500" b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 (s)</a:t>
                      </a:r>
                      <a:endParaRPr lang="en-CA" sz="15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4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5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4.96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3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5.21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64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01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42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9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.0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55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8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69789629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0.65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0.75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.66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0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13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59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52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9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3.13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4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48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89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176983710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4A69844-2B44-B741-9215-CB53F60E184F}"/>
              </a:ext>
            </a:extLst>
          </p:cNvPr>
          <p:cNvSpPr txBox="1"/>
          <p:nvPr/>
        </p:nvSpPr>
        <p:spPr>
          <a:xfrm>
            <a:off x="9856506" y="156410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3014805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54B56671-35BE-D448-8245-FA074B1092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8920" y="915067"/>
            <a:ext cx="5842000" cy="4381500"/>
          </a:xfrm>
          <a:prstGeom prst="rect">
            <a:avLst/>
          </a:prstGeom>
        </p:spPr>
      </p:pic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EBFB2F46-58AA-9948-B638-31CEB243D4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999" y="915067"/>
            <a:ext cx="5842000" cy="4381500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6E626C9E-37BE-C94B-808A-02573426E1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999" y="915067"/>
            <a:ext cx="5842000" cy="43815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802A095-9285-2B4C-AACF-4250554F0AFD}"/>
              </a:ext>
            </a:extLst>
          </p:cNvPr>
          <p:cNvSpPr txBox="1"/>
          <p:nvPr/>
        </p:nvSpPr>
        <p:spPr>
          <a:xfrm rot="16200000">
            <a:off x="-539672" y="2867289"/>
            <a:ext cx="2090957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i="1" dirty="0"/>
              <a:t>rCBV</a:t>
            </a:r>
            <a:r>
              <a:rPr lang="en-US" sz="2500" b="1" dirty="0"/>
              <a:t> Accurac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900CB9-7128-D44B-A5D1-5E458BF6869E}"/>
              </a:ext>
            </a:extLst>
          </p:cNvPr>
          <p:cNvSpPr txBox="1"/>
          <p:nvPr/>
        </p:nvSpPr>
        <p:spPr>
          <a:xfrm>
            <a:off x="1581197" y="5059858"/>
            <a:ext cx="368120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500" b="1" dirty="0"/>
              <a:t>Normalizing Voxel </a:t>
            </a:r>
            <a:r>
              <a:rPr lang="en-US" sz="2500" b="1" i="1" dirty="0"/>
              <a:t>CBV</a:t>
            </a:r>
            <a:r>
              <a:rPr lang="en-US" sz="2500" b="1" dirty="0"/>
              <a:t> (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8E630F-19E2-0A41-ABCC-7FD857B53811}"/>
              </a:ext>
            </a:extLst>
          </p:cNvPr>
          <p:cNvSpPr txBox="1"/>
          <p:nvPr/>
        </p:nvSpPr>
        <p:spPr>
          <a:xfrm rot="16200000">
            <a:off x="5238249" y="2867293"/>
            <a:ext cx="2090957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i="1" dirty="0"/>
              <a:t>rCBV</a:t>
            </a:r>
            <a:r>
              <a:rPr lang="en-US" sz="2500" b="1" dirty="0"/>
              <a:t> Accurac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49E7FC-D7CE-1548-B515-315CEB4641C6}"/>
              </a:ext>
            </a:extLst>
          </p:cNvPr>
          <p:cNvSpPr txBox="1"/>
          <p:nvPr/>
        </p:nvSpPr>
        <p:spPr>
          <a:xfrm>
            <a:off x="7355593" y="5059862"/>
            <a:ext cx="3688254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500" b="1" dirty="0"/>
              <a:t>Normalizing Voxel </a:t>
            </a:r>
            <a:r>
              <a:rPr lang="en-US" sz="2500" b="1" i="1" dirty="0"/>
              <a:t>CBV</a:t>
            </a:r>
            <a:r>
              <a:rPr lang="en-US" sz="2500" b="1" dirty="0"/>
              <a:t> (%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4BCE58C-8308-6048-ABAE-1361C165E1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89514" y="2299033"/>
            <a:ext cx="419100" cy="4191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013D2D4-DBD1-AE48-BCD8-4DE76F9CCB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25778" y="2718133"/>
            <a:ext cx="342900" cy="304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6F007A1-2282-E14F-B6C4-2A9A15B4E7C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14914" y="1561433"/>
            <a:ext cx="381000" cy="381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77BA45A-4807-B644-87B8-EF053474689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33964" y="1960817"/>
            <a:ext cx="361950" cy="337820"/>
          </a:xfrm>
          <a:prstGeom prst="rect">
            <a:avLst/>
          </a:prstGeom>
        </p:spPr>
      </p:pic>
      <p:sp>
        <p:nvSpPr>
          <p:cNvPr id="17" name="Frame 16">
            <a:extLst>
              <a:ext uri="{FF2B5EF4-FFF2-40B4-BE49-F238E27FC236}">
                <a16:creationId xmlns:a16="http://schemas.microsoft.com/office/drawing/2014/main" id="{814E229B-D344-1348-B874-057C880A521B}"/>
              </a:ext>
            </a:extLst>
          </p:cNvPr>
          <p:cNvSpPr/>
          <p:nvPr/>
        </p:nvSpPr>
        <p:spPr>
          <a:xfrm>
            <a:off x="7025777" y="1560331"/>
            <a:ext cx="3442021" cy="1462602"/>
          </a:xfrm>
          <a:prstGeom prst="frame">
            <a:avLst>
              <a:gd name="adj1" fmla="val 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981EE9D5-4CE9-564D-9AA3-F05A2BE2C530}"/>
              </a:ext>
            </a:extLst>
          </p:cNvPr>
          <p:cNvSpPr/>
          <p:nvPr/>
        </p:nvSpPr>
        <p:spPr>
          <a:xfrm>
            <a:off x="1062467" y="4739356"/>
            <a:ext cx="10665693" cy="3385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25C1F04-27E4-0045-9E73-8E69E538979D}"/>
              </a:ext>
            </a:extLst>
          </p:cNvPr>
          <p:cNvCxnSpPr>
            <a:cxnSpLocks/>
          </p:cNvCxnSpPr>
          <p:nvPr/>
        </p:nvCxnSpPr>
        <p:spPr>
          <a:xfrm flipV="1">
            <a:off x="5914690" y="3297492"/>
            <a:ext cx="0" cy="8562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AC90D97C-072D-1F49-80E0-0152240897B8}"/>
              </a:ext>
            </a:extLst>
          </p:cNvPr>
          <p:cNvSpPr txBox="1"/>
          <p:nvPr/>
        </p:nvSpPr>
        <p:spPr>
          <a:xfrm>
            <a:off x="6771520" y="2343892"/>
            <a:ext cx="38748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Small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High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D9E9FD-5D97-9642-B322-C25904681958}"/>
              </a:ext>
            </a:extLst>
          </p:cNvPr>
          <p:cNvSpPr txBox="1"/>
          <p:nvPr/>
        </p:nvSpPr>
        <p:spPr>
          <a:xfrm>
            <a:off x="7300757" y="1582248"/>
            <a:ext cx="28163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Large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High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  <a:p>
            <a:pPr algn="ctr"/>
            <a:endParaRPr lang="en-US" sz="1600" i="1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ABBEACF-C107-7244-A821-217190A2D757}"/>
              </a:ext>
            </a:extLst>
          </p:cNvPr>
          <p:cNvSpPr txBox="1"/>
          <p:nvPr/>
        </p:nvSpPr>
        <p:spPr>
          <a:xfrm>
            <a:off x="7214939" y="1983881"/>
            <a:ext cx="3252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Medium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baseline="-25000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High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9D4A8F-640E-D746-9774-F0EF7EA1CE0B}"/>
              </a:ext>
            </a:extLst>
          </p:cNvPr>
          <p:cNvSpPr txBox="1"/>
          <p:nvPr/>
        </p:nvSpPr>
        <p:spPr>
          <a:xfrm>
            <a:off x="6891541" y="2725725"/>
            <a:ext cx="35762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Small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Low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FE90FE3-48F8-E845-8756-622584B14BDB}"/>
              </a:ext>
            </a:extLst>
          </p:cNvPr>
          <p:cNvSpPr txBox="1"/>
          <p:nvPr/>
        </p:nvSpPr>
        <p:spPr>
          <a:xfrm>
            <a:off x="1196705" y="4800068"/>
            <a:ext cx="4604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    20           40            60           80           100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ADD6D9BE-ACE3-DE4B-9DF7-70ABFEB5583B}"/>
              </a:ext>
            </a:extLst>
          </p:cNvPr>
          <p:cNvSpPr/>
          <p:nvPr/>
        </p:nvSpPr>
        <p:spPr>
          <a:xfrm flipV="1">
            <a:off x="768369" y="1235785"/>
            <a:ext cx="509334" cy="3534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D32B405-173F-1D40-B2B4-2791AC334681}"/>
              </a:ext>
            </a:extLst>
          </p:cNvPr>
          <p:cNvCxnSpPr>
            <a:cxnSpLocks/>
          </p:cNvCxnSpPr>
          <p:nvPr/>
        </p:nvCxnSpPr>
        <p:spPr>
          <a:xfrm>
            <a:off x="1116335" y="1417892"/>
            <a:ext cx="0" cy="3401708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B454E90F-0688-A04B-A4E4-61E65A3545DC}"/>
              </a:ext>
            </a:extLst>
          </p:cNvPr>
          <p:cNvSpPr txBox="1"/>
          <p:nvPr/>
        </p:nvSpPr>
        <p:spPr>
          <a:xfrm>
            <a:off x="838206" y="4013555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-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8E86617-CCC2-FF4E-B2DF-F939ED2039D4}"/>
              </a:ext>
            </a:extLst>
          </p:cNvPr>
          <p:cNvSpPr/>
          <p:nvPr/>
        </p:nvSpPr>
        <p:spPr>
          <a:xfrm>
            <a:off x="1070043" y="1357181"/>
            <a:ext cx="4679004" cy="1214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B4ACCB92-C482-A64D-B90E-3AD775E41484}"/>
              </a:ext>
            </a:extLst>
          </p:cNvPr>
          <p:cNvSpPr/>
          <p:nvPr/>
        </p:nvSpPr>
        <p:spPr>
          <a:xfrm>
            <a:off x="5570637" y="1357181"/>
            <a:ext cx="188065" cy="34624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7075AAB-747D-2F4A-B772-76CBCE69ED45}"/>
              </a:ext>
            </a:extLst>
          </p:cNvPr>
          <p:cNvSpPr/>
          <p:nvPr/>
        </p:nvSpPr>
        <p:spPr>
          <a:xfrm>
            <a:off x="6865336" y="1357181"/>
            <a:ext cx="4679004" cy="1214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E470637B-9166-B84A-BBFD-78938EC835D6}"/>
              </a:ext>
            </a:extLst>
          </p:cNvPr>
          <p:cNvSpPr/>
          <p:nvPr/>
        </p:nvSpPr>
        <p:spPr>
          <a:xfrm flipV="1">
            <a:off x="6450773" y="1324203"/>
            <a:ext cx="509334" cy="3534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F40C666F-323F-614D-9421-75D6B25535CF}"/>
              </a:ext>
            </a:extLst>
          </p:cNvPr>
          <p:cNvSpPr/>
          <p:nvPr/>
        </p:nvSpPr>
        <p:spPr>
          <a:xfrm>
            <a:off x="11365930" y="1357181"/>
            <a:ext cx="188065" cy="34624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7BCEE8F-0D0B-B84D-9691-CDE67F9FB192}"/>
              </a:ext>
            </a:extLst>
          </p:cNvPr>
          <p:cNvCxnSpPr>
            <a:cxnSpLocks/>
          </p:cNvCxnSpPr>
          <p:nvPr/>
        </p:nvCxnSpPr>
        <p:spPr>
          <a:xfrm flipH="1">
            <a:off x="1116336" y="4819600"/>
            <a:ext cx="454833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4D6509CE-D09A-DB41-B73A-7337F15C2F69}"/>
              </a:ext>
            </a:extLst>
          </p:cNvPr>
          <p:cNvCxnSpPr>
            <a:cxnSpLocks/>
          </p:cNvCxnSpPr>
          <p:nvPr/>
        </p:nvCxnSpPr>
        <p:spPr>
          <a:xfrm>
            <a:off x="6891540" y="1417892"/>
            <a:ext cx="0" cy="3401708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30293B5-93E6-F848-9CCE-FF2DA8506AE6}"/>
              </a:ext>
            </a:extLst>
          </p:cNvPr>
          <p:cNvCxnSpPr>
            <a:cxnSpLocks/>
          </p:cNvCxnSpPr>
          <p:nvPr/>
        </p:nvCxnSpPr>
        <p:spPr>
          <a:xfrm flipH="1">
            <a:off x="6891541" y="4819600"/>
            <a:ext cx="454833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C199FE4F-E14F-5B48-97E1-33E21D9EC46B}"/>
              </a:ext>
            </a:extLst>
          </p:cNvPr>
          <p:cNvSpPr txBox="1"/>
          <p:nvPr/>
        </p:nvSpPr>
        <p:spPr>
          <a:xfrm>
            <a:off x="6968399" y="4800068"/>
            <a:ext cx="4604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    20           40            60           80           1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462040D-58C2-6E4A-BBA9-2DC2EC80BC53}"/>
              </a:ext>
            </a:extLst>
          </p:cNvPr>
          <p:cNvSpPr txBox="1"/>
          <p:nvPr/>
        </p:nvSpPr>
        <p:spPr>
          <a:xfrm>
            <a:off x="839808" y="3333831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DFBDF3D-35ED-AD4E-A034-18C1E69EF026}"/>
              </a:ext>
            </a:extLst>
          </p:cNvPr>
          <p:cNvSpPr txBox="1"/>
          <p:nvPr/>
        </p:nvSpPr>
        <p:spPr>
          <a:xfrm>
            <a:off x="840869" y="2665342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8E165F0-CD4A-3540-8098-7E0C6FBD98D3}"/>
              </a:ext>
            </a:extLst>
          </p:cNvPr>
          <p:cNvSpPr txBox="1"/>
          <p:nvPr/>
        </p:nvSpPr>
        <p:spPr>
          <a:xfrm>
            <a:off x="840262" y="197634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8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D13A484-3264-844E-943E-E9964221E501}"/>
              </a:ext>
            </a:extLst>
          </p:cNvPr>
          <p:cNvSpPr txBox="1"/>
          <p:nvPr/>
        </p:nvSpPr>
        <p:spPr>
          <a:xfrm>
            <a:off x="721349" y="1306385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DB4AFA2-1CB4-D740-9897-A668CF789D41}"/>
              </a:ext>
            </a:extLst>
          </p:cNvPr>
          <p:cNvSpPr txBox="1"/>
          <p:nvPr/>
        </p:nvSpPr>
        <p:spPr>
          <a:xfrm>
            <a:off x="834693" y="460058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5D30169-0DA8-C941-95B4-314A1888B1D3}"/>
              </a:ext>
            </a:extLst>
          </p:cNvPr>
          <p:cNvSpPr txBox="1"/>
          <p:nvPr/>
        </p:nvSpPr>
        <p:spPr>
          <a:xfrm>
            <a:off x="6614046" y="391953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-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4A1B698-FA82-5340-B102-F54954D2DBF0}"/>
              </a:ext>
            </a:extLst>
          </p:cNvPr>
          <p:cNvSpPr txBox="1"/>
          <p:nvPr/>
        </p:nvSpPr>
        <p:spPr>
          <a:xfrm>
            <a:off x="6493515" y="326909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4C86106-A1FE-DF42-880F-0E359B992290}"/>
              </a:ext>
            </a:extLst>
          </p:cNvPr>
          <p:cNvSpPr txBox="1"/>
          <p:nvPr/>
        </p:nvSpPr>
        <p:spPr>
          <a:xfrm>
            <a:off x="6610533" y="4571415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589CB24-7ECB-EC4E-8ED1-C05BBD2DF5B8}"/>
              </a:ext>
            </a:extLst>
          </p:cNvPr>
          <p:cNvSpPr txBox="1"/>
          <p:nvPr/>
        </p:nvSpPr>
        <p:spPr>
          <a:xfrm>
            <a:off x="6491565" y="262493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5-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EA6FAD7-5ED7-A24C-AB2B-02B25AE77983}"/>
              </a:ext>
            </a:extLst>
          </p:cNvPr>
          <p:cNvSpPr txBox="1"/>
          <p:nvPr/>
        </p:nvSpPr>
        <p:spPr>
          <a:xfrm>
            <a:off x="6491113" y="197109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-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AE1A0F6E-D7D1-A840-91DF-47BEE5C1E0F6}"/>
              </a:ext>
            </a:extLst>
          </p:cNvPr>
          <p:cNvSpPr txBox="1"/>
          <p:nvPr/>
        </p:nvSpPr>
        <p:spPr>
          <a:xfrm>
            <a:off x="6494718" y="131954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5-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77868E77-9F0D-A547-ABEB-0B019D7CB6EC}"/>
              </a:ext>
            </a:extLst>
          </p:cNvPr>
          <p:cNvCxnSpPr>
            <a:cxnSpLocks/>
          </p:cNvCxnSpPr>
          <p:nvPr/>
        </p:nvCxnSpPr>
        <p:spPr>
          <a:xfrm>
            <a:off x="1342480" y="4824492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79FD43A-A65C-B144-AD40-11355DC89AE8}"/>
              </a:ext>
            </a:extLst>
          </p:cNvPr>
          <p:cNvCxnSpPr>
            <a:cxnSpLocks/>
          </p:cNvCxnSpPr>
          <p:nvPr/>
        </p:nvCxnSpPr>
        <p:spPr>
          <a:xfrm>
            <a:off x="2143261" y="481632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CFB416C-3533-5248-BA26-F16BFEEF4A0B}"/>
              </a:ext>
            </a:extLst>
          </p:cNvPr>
          <p:cNvCxnSpPr>
            <a:cxnSpLocks/>
          </p:cNvCxnSpPr>
          <p:nvPr/>
        </p:nvCxnSpPr>
        <p:spPr>
          <a:xfrm>
            <a:off x="2969251" y="4810690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0FAF48B9-019A-7A44-843C-09EA16DD194D}"/>
              </a:ext>
            </a:extLst>
          </p:cNvPr>
          <p:cNvCxnSpPr>
            <a:cxnSpLocks/>
          </p:cNvCxnSpPr>
          <p:nvPr/>
        </p:nvCxnSpPr>
        <p:spPr>
          <a:xfrm>
            <a:off x="3800481" y="4810690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4A6E1A36-F2DE-304C-8B5F-76C673ED05F0}"/>
              </a:ext>
            </a:extLst>
          </p:cNvPr>
          <p:cNvCxnSpPr>
            <a:cxnSpLocks/>
          </p:cNvCxnSpPr>
          <p:nvPr/>
        </p:nvCxnSpPr>
        <p:spPr>
          <a:xfrm>
            <a:off x="4611988" y="481574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4A752C2F-849B-184E-AB2F-DF7D1F1E2E84}"/>
              </a:ext>
            </a:extLst>
          </p:cNvPr>
          <p:cNvCxnSpPr>
            <a:cxnSpLocks/>
          </p:cNvCxnSpPr>
          <p:nvPr/>
        </p:nvCxnSpPr>
        <p:spPr>
          <a:xfrm>
            <a:off x="5455005" y="4816461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79B67CD8-D8DE-1D4A-94A1-60C8FFC7F316}"/>
              </a:ext>
            </a:extLst>
          </p:cNvPr>
          <p:cNvCxnSpPr>
            <a:cxnSpLocks/>
          </p:cNvCxnSpPr>
          <p:nvPr/>
        </p:nvCxnSpPr>
        <p:spPr>
          <a:xfrm>
            <a:off x="7115134" y="4831578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DED6E4AF-5367-6547-81C5-A25E738059C2}"/>
              </a:ext>
            </a:extLst>
          </p:cNvPr>
          <p:cNvCxnSpPr>
            <a:cxnSpLocks/>
          </p:cNvCxnSpPr>
          <p:nvPr/>
        </p:nvCxnSpPr>
        <p:spPr>
          <a:xfrm>
            <a:off x="7915915" y="4823415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AECF07BF-C0A4-D341-AD0A-9CB28CCA7D37}"/>
              </a:ext>
            </a:extLst>
          </p:cNvPr>
          <p:cNvCxnSpPr>
            <a:cxnSpLocks/>
          </p:cNvCxnSpPr>
          <p:nvPr/>
        </p:nvCxnSpPr>
        <p:spPr>
          <a:xfrm>
            <a:off x="8741905" y="4817776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61259D3F-BDC1-7845-B1C8-1D1D9DC0EECD}"/>
              </a:ext>
            </a:extLst>
          </p:cNvPr>
          <p:cNvCxnSpPr>
            <a:cxnSpLocks/>
          </p:cNvCxnSpPr>
          <p:nvPr/>
        </p:nvCxnSpPr>
        <p:spPr>
          <a:xfrm>
            <a:off x="9573135" y="4817776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C7FA2CAA-6F87-D64D-AC3F-8D255365484C}"/>
              </a:ext>
            </a:extLst>
          </p:cNvPr>
          <p:cNvCxnSpPr>
            <a:cxnSpLocks/>
          </p:cNvCxnSpPr>
          <p:nvPr/>
        </p:nvCxnSpPr>
        <p:spPr>
          <a:xfrm>
            <a:off x="10384642" y="482282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C4895F7C-C0A8-B642-ABB0-3647D0AD56C7}"/>
              </a:ext>
            </a:extLst>
          </p:cNvPr>
          <p:cNvCxnSpPr>
            <a:cxnSpLocks/>
          </p:cNvCxnSpPr>
          <p:nvPr/>
        </p:nvCxnSpPr>
        <p:spPr>
          <a:xfrm>
            <a:off x="11227659" y="4823547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C91BF37F-12A7-5340-94C2-44A611308128}"/>
              </a:ext>
            </a:extLst>
          </p:cNvPr>
          <p:cNvSpPr txBox="1"/>
          <p:nvPr/>
        </p:nvSpPr>
        <p:spPr>
          <a:xfrm>
            <a:off x="9856506" y="15641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57466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Qr code&#10;&#10;Description automatically generated with low confidence">
            <a:extLst>
              <a:ext uri="{FF2B5EF4-FFF2-40B4-BE49-F238E27FC236}">
                <a16:creationId xmlns:a16="http://schemas.microsoft.com/office/drawing/2014/main" id="{86C0CD53-B4FB-ED4E-8914-FC9953F809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650" y="1333500"/>
            <a:ext cx="11188700" cy="4191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2B16B97-83C8-E948-9B28-2BE0C5B83129}"/>
              </a:ext>
            </a:extLst>
          </p:cNvPr>
          <p:cNvSpPr txBox="1"/>
          <p:nvPr/>
        </p:nvSpPr>
        <p:spPr>
          <a:xfrm>
            <a:off x="9856506" y="15641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362554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reeform 4">
            <a:extLst>
              <a:ext uri="{FF2B5EF4-FFF2-40B4-BE49-F238E27FC236}">
                <a16:creationId xmlns:a16="http://schemas.microsoft.com/office/drawing/2014/main" id="{C280830F-2FD2-9E4C-B888-E4EE500B2D4A}"/>
              </a:ext>
            </a:extLst>
          </p:cNvPr>
          <p:cNvSpPr/>
          <p:nvPr/>
        </p:nvSpPr>
        <p:spPr>
          <a:xfrm>
            <a:off x="675564" y="2486427"/>
            <a:ext cx="668740" cy="2197289"/>
          </a:xfrm>
          <a:custGeom>
            <a:avLst/>
            <a:gdLst>
              <a:gd name="connsiteX0" fmla="*/ 0 w 668740"/>
              <a:gd name="connsiteY0" fmla="*/ 0 h 2197289"/>
              <a:gd name="connsiteX1" fmla="*/ 0 w 668740"/>
              <a:gd name="connsiteY1" fmla="*/ 2197289 h 2197289"/>
              <a:gd name="connsiteX2" fmla="*/ 668740 w 668740"/>
              <a:gd name="connsiteY2" fmla="*/ 2197289 h 2197289"/>
              <a:gd name="connsiteX3" fmla="*/ 668740 w 668740"/>
              <a:gd name="connsiteY3" fmla="*/ 1398895 h 2197289"/>
              <a:gd name="connsiteX4" fmla="*/ 402609 w 668740"/>
              <a:gd name="connsiteY4" fmla="*/ 1139588 h 2197289"/>
              <a:gd name="connsiteX5" fmla="*/ 293427 w 668740"/>
              <a:gd name="connsiteY5" fmla="*/ 948519 h 2197289"/>
              <a:gd name="connsiteX6" fmla="*/ 191069 w 668740"/>
              <a:gd name="connsiteY6" fmla="*/ 696036 h 2197289"/>
              <a:gd name="connsiteX7" fmla="*/ 102358 w 668740"/>
              <a:gd name="connsiteY7" fmla="*/ 491319 h 2197289"/>
              <a:gd name="connsiteX8" fmla="*/ 0 w 668740"/>
              <a:gd name="connsiteY8" fmla="*/ 0 h 21972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668740" h="2197289">
                <a:moveTo>
                  <a:pt x="0" y="0"/>
                </a:moveTo>
                <a:lnTo>
                  <a:pt x="0" y="2197289"/>
                </a:lnTo>
                <a:lnTo>
                  <a:pt x="668740" y="2197289"/>
                </a:lnTo>
                <a:lnTo>
                  <a:pt x="668740" y="1398895"/>
                </a:lnTo>
                <a:lnTo>
                  <a:pt x="402609" y="1139588"/>
                </a:lnTo>
                <a:lnTo>
                  <a:pt x="293427" y="948519"/>
                </a:lnTo>
                <a:lnTo>
                  <a:pt x="191069" y="696036"/>
                </a:lnTo>
                <a:lnTo>
                  <a:pt x="102358" y="49131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alpha val="50000"/>
            </a:scheme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endParaRPr lang="en-US" sz="1500" dirty="0">
              <a:solidFill>
                <a:srgbClr val="002060"/>
              </a:solidFill>
            </a:endParaRPr>
          </a:p>
          <a:p>
            <a:pPr algn="ctr"/>
            <a:r>
              <a:rPr lang="en-US" sz="1500" b="1" dirty="0">
                <a:solidFill>
                  <a:srgbClr val="002060"/>
                </a:solidFill>
              </a:rPr>
              <a:t>dOHb</a:t>
            </a:r>
          </a:p>
        </p:txBody>
      </p:sp>
      <p:sp>
        <p:nvSpPr>
          <p:cNvPr id="6" name="Freeform 5">
            <a:extLst>
              <a:ext uri="{FF2B5EF4-FFF2-40B4-BE49-F238E27FC236}">
                <a16:creationId xmlns:a16="http://schemas.microsoft.com/office/drawing/2014/main" id="{DE62E9D2-6933-7345-8724-ABFACE44AF70}"/>
              </a:ext>
            </a:extLst>
          </p:cNvPr>
          <p:cNvSpPr/>
          <p:nvPr/>
        </p:nvSpPr>
        <p:spPr>
          <a:xfrm>
            <a:off x="2108579" y="4216456"/>
            <a:ext cx="2927445" cy="460437"/>
          </a:xfrm>
          <a:custGeom>
            <a:avLst/>
            <a:gdLst>
              <a:gd name="connsiteX0" fmla="*/ 13648 w 2927445"/>
              <a:gd name="connsiteY0" fmla="*/ 443553 h 443553"/>
              <a:gd name="connsiteX1" fmla="*/ 2927445 w 2927445"/>
              <a:gd name="connsiteY1" fmla="*/ 443553 h 443553"/>
              <a:gd name="connsiteX2" fmla="*/ 2927445 w 2927445"/>
              <a:gd name="connsiteY2" fmla="*/ 272955 h 443553"/>
              <a:gd name="connsiteX3" fmla="*/ 2060812 w 2927445"/>
              <a:gd name="connsiteY3" fmla="*/ 238836 h 443553"/>
              <a:gd name="connsiteX4" fmla="*/ 1412543 w 2927445"/>
              <a:gd name="connsiteY4" fmla="*/ 191069 h 443553"/>
              <a:gd name="connsiteX5" fmla="*/ 928048 w 2927445"/>
              <a:gd name="connsiteY5" fmla="*/ 156950 h 443553"/>
              <a:gd name="connsiteX6" fmla="*/ 88711 w 2927445"/>
              <a:gd name="connsiteY6" fmla="*/ 27296 h 443553"/>
              <a:gd name="connsiteX7" fmla="*/ 0 w 2927445"/>
              <a:gd name="connsiteY7" fmla="*/ 0 h 443553"/>
              <a:gd name="connsiteX8" fmla="*/ 13648 w 2927445"/>
              <a:gd name="connsiteY8" fmla="*/ 443553 h 443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927445" h="443553">
                <a:moveTo>
                  <a:pt x="13648" y="443553"/>
                </a:moveTo>
                <a:lnTo>
                  <a:pt x="2927445" y="443553"/>
                </a:lnTo>
                <a:lnTo>
                  <a:pt x="2927445" y="272955"/>
                </a:lnTo>
                <a:lnTo>
                  <a:pt x="2060812" y="238836"/>
                </a:lnTo>
                <a:lnTo>
                  <a:pt x="1412543" y="191069"/>
                </a:lnTo>
                <a:lnTo>
                  <a:pt x="928048" y="156950"/>
                </a:lnTo>
                <a:lnTo>
                  <a:pt x="88711" y="27296"/>
                </a:lnTo>
                <a:lnTo>
                  <a:pt x="0" y="0"/>
                </a:lnTo>
                <a:lnTo>
                  <a:pt x="13648" y="443553"/>
                </a:lnTo>
                <a:close/>
              </a:path>
            </a:pathLst>
          </a:custGeom>
          <a:solidFill>
            <a:srgbClr val="C00000">
              <a:alpha val="25000"/>
            </a:srgb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Freeform 6">
            <a:extLst>
              <a:ext uri="{FF2B5EF4-FFF2-40B4-BE49-F238E27FC236}">
                <a16:creationId xmlns:a16="http://schemas.microsoft.com/office/drawing/2014/main" id="{06A22916-6071-3A40-ABC8-D79412FCFD1C}"/>
              </a:ext>
            </a:extLst>
          </p:cNvPr>
          <p:cNvSpPr/>
          <p:nvPr/>
        </p:nvSpPr>
        <p:spPr>
          <a:xfrm>
            <a:off x="6928574" y="4053080"/>
            <a:ext cx="638239" cy="625965"/>
          </a:xfrm>
          <a:custGeom>
            <a:avLst/>
            <a:gdLst>
              <a:gd name="connsiteX0" fmla="*/ 6137 w 638239"/>
              <a:gd name="connsiteY0" fmla="*/ 625965 h 625965"/>
              <a:gd name="connsiteX1" fmla="*/ 0 w 638239"/>
              <a:gd name="connsiteY1" fmla="*/ 392762 h 625965"/>
              <a:gd name="connsiteX2" fmla="*/ 460269 w 638239"/>
              <a:gd name="connsiteY2" fmla="*/ 104327 h 625965"/>
              <a:gd name="connsiteX3" fmla="*/ 638239 w 638239"/>
              <a:gd name="connsiteY3" fmla="*/ 0 h 625965"/>
              <a:gd name="connsiteX4" fmla="*/ 638239 w 638239"/>
              <a:gd name="connsiteY4" fmla="*/ 625965 h 625965"/>
              <a:gd name="connsiteX5" fmla="*/ 6137 w 638239"/>
              <a:gd name="connsiteY5" fmla="*/ 625965 h 6259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38239" h="625965">
                <a:moveTo>
                  <a:pt x="6137" y="625965"/>
                </a:moveTo>
                <a:lnTo>
                  <a:pt x="0" y="392762"/>
                </a:lnTo>
                <a:lnTo>
                  <a:pt x="460269" y="104327"/>
                </a:lnTo>
                <a:lnTo>
                  <a:pt x="638239" y="0"/>
                </a:lnTo>
                <a:lnTo>
                  <a:pt x="638239" y="625965"/>
                </a:lnTo>
                <a:lnTo>
                  <a:pt x="6137" y="625965"/>
                </a:lnTo>
                <a:close/>
              </a:path>
            </a:pathLst>
          </a:custGeom>
          <a:solidFill>
            <a:schemeClr val="accent1">
              <a:alpha val="50000"/>
            </a:scheme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reeform 8">
            <a:extLst>
              <a:ext uri="{FF2B5EF4-FFF2-40B4-BE49-F238E27FC236}">
                <a16:creationId xmlns:a16="http://schemas.microsoft.com/office/drawing/2014/main" id="{88AFE33F-C7CB-7343-8B0F-7397296A7249}"/>
              </a:ext>
            </a:extLst>
          </p:cNvPr>
          <p:cNvSpPr/>
          <p:nvPr/>
        </p:nvSpPr>
        <p:spPr>
          <a:xfrm>
            <a:off x="8327791" y="2494304"/>
            <a:ext cx="2847527" cy="2190878"/>
          </a:xfrm>
          <a:custGeom>
            <a:avLst/>
            <a:gdLst>
              <a:gd name="connsiteX0" fmla="*/ 0 w 2847527"/>
              <a:gd name="connsiteY0" fmla="*/ 2178604 h 2190878"/>
              <a:gd name="connsiteX1" fmla="*/ 6137 w 2847527"/>
              <a:gd name="connsiteY1" fmla="*/ 1129192 h 2190878"/>
              <a:gd name="connsiteX2" fmla="*/ 1104644 w 2847527"/>
              <a:gd name="connsiteY2" fmla="*/ 638239 h 2190878"/>
              <a:gd name="connsiteX3" fmla="*/ 2209288 w 2847527"/>
              <a:gd name="connsiteY3" fmla="*/ 214792 h 2190878"/>
              <a:gd name="connsiteX4" fmla="*/ 2847527 w 2847527"/>
              <a:gd name="connsiteY4" fmla="*/ 0 h 2190878"/>
              <a:gd name="connsiteX5" fmla="*/ 2835253 w 2847527"/>
              <a:gd name="connsiteY5" fmla="*/ 2190878 h 2190878"/>
              <a:gd name="connsiteX6" fmla="*/ 0 w 2847527"/>
              <a:gd name="connsiteY6" fmla="*/ 2178604 h 21908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847527" h="2190878">
                <a:moveTo>
                  <a:pt x="0" y="2178604"/>
                </a:moveTo>
                <a:cubicBezTo>
                  <a:pt x="2046" y="1828800"/>
                  <a:pt x="4091" y="1478996"/>
                  <a:pt x="6137" y="1129192"/>
                </a:cubicBezTo>
                <a:lnTo>
                  <a:pt x="1104644" y="638239"/>
                </a:lnTo>
                <a:lnTo>
                  <a:pt x="2209288" y="214792"/>
                </a:lnTo>
                <a:lnTo>
                  <a:pt x="2847527" y="0"/>
                </a:lnTo>
                <a:cubicBezTo>
                  <a:pt x="2843436" y="730293"/>
                  <a:pt x="2839344" y="1460585"/>
                  <a:pt x="2835253" y="2190878"/>
                </a:cubicBezTo>
                <a:lnTo>
                  <a:pt x="0" y="2178604"/>
                </a:lnTo>
                <a:close/>
              </a:path>
            </a:pathLst>
          </a:custGeom>
          <a:solidFill>
            <a:srgbClr val="C00000">
              <a:alpha val="25000"/>
            </a:srgb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451FF6FC-9749-9C48-A096-03207BD95303}"/>
              </a:ext>
            </a:extLst>
          </p:cNvPr>
          <p:cNvGraphicFramePr>
            <a:graphicFrameLocks/>
          </p:cNvGraphicFramePr>
          <p:nvPr/>
        </p:nvGraphicFramePr>
        <p:xfrm>
          <a:off x="6039117" y="1476729"/>
          <a:ext cx="6108735" cy="4031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1673295E-A8DF-1E48-BCB4-11A1CC64337E}"/>
              </a:ext>
            </a:extLst>
          </p:cNvPr>
          <p:cNvGraphicFramePr>
            <a:graphicFrameLocks/>
          </p:cNvGraphicFramePr>
          <p:nvPr/>
        </p:nvGraphicFramePr>
        <p:xfrm>
          <a:off x="-74842" y="1483039"/>
          <a:ext cx="6108735" cy="4031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C363341-A0DB-C241-8888-72A86A43EC1D}"/>
              </a:ext>
            </a:extLst>
          </p:cNvPr>
          <p:cNvSpPr txBox="1"/>
          <p:nvPr/>
        </p:nvSpPr>
        <p:spPr>
          <a:xfrm>
            <a:off x="2676939" y="4366062"/>
            <a:ext cx="4074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C00000"/>
                </a:solidFill>
              </a:rPr>
              <a:t>G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4B8CC34-3E75-024A-86CA-8B78B4CF84EC}"/>
              </a:ext>
            </a:extLst>
          </p:cNvPr>
          <p:cNvSpPr txBox="1"/>
          <p:nvPr/>
        </p:nvSpPr>
        <p:spPr>
          <a:xfrm>
            <a:off x="9574316" y="3769671"/>
            <a:ext cx="4074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C00000"/>
                </a:solidFill>
              </a:rPr>
              <a:t>G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FD92C33-88F6-CE47-89EE-8DBA1EE1F965}"/>
              </a:ext>
            </a:extLst>
          </p:cNvPr>
          <p:cNvSpPr txBox="1"/>
          <p:nvPr/>
        </p:nvSpPr>
        <p:spPr>
          <a:xfrm>
            <a:off x="6928574" y="4338817"/>
            <a:ext cx="64152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2060"/>
                </a:solidFill>
              </a:rPr>
              <a:t>dOH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77DEFF0-D000-2945-A5F1-4C7C38253140}"/>
              </a:ext>
            </a:extLst>
          </p:cNvPr>
          <p:cNvSpPr txBox="1"/>
          <p:nvPr/>
        </p:nvSpPr>
        <p:spPr>
          <a:xfrm>
            <a:off x="9856506" y="15641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8511279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48721518-1B47-8842-B9D0-B167947D44A5}"/>
              </a:ext>
            </a:extLst>
          </p:cNvPr>
          <p:cNvGraphicFramePr>
            <a:graphicFrameLocks/>
          </p:cNvGraphicFramePr>
          <p:nvPr/>
        </p:nvGraphicFramePr>
        <p:xfrm>
          <a:off x="3810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EB6D9AD9-1B24-7245-A3F7-DFC486BEEF12}"/>
              </a:ext>
            </a:extLst>
          </p:cNvPr>
          <p:cNvSpPr/>
          <p:nvPr/>
        </p:nvSpPr>
        <p:spPr>
          <a:xfrm>
            <a:off x="4119073" y="4554908"/>
            <a:ext cx="4262927" cy="2456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5533447-4DA9-7C41-B6EE-904C6F4BE601}"/>
              </a:ext>
            </a:extLst>
          </p:cNvPr>
          <p:cNvSpPr txBox="1"/>
          <p:nvPr/>
        </p:nvSpPr>
        <p:spPr>
          <a:xfrm>
            <a:off x="4226314" y="4505508"/>
            <a:ext cx="113742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/>
              <a:t>Arteria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DFE869-1295-BD4F-A293-2370EF88303C}"/>
              </a:ext>
            </a:extLst>
          </p:cNvPr>
          <p:cNvSpPr txBox="1"/>
          <p:nvPr/>
        </p:nvSpPr>
        <p:spPr>
          <a:xfrm>
            <a:off x="5211340" y="4505508"/>
            <a:ext cx="113742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/>
              <a:t>Venou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C7F4C2F-7FD6-424B-A752-C4569F3DA740}"/>
              </a:ext>
            </a:extLst>
          </p:cNvPr>
          <p:cNvSpPr txBox="1"/>
          <p:nvPr/>
        </p:nvSpPr>
        <p:spPr>
          <a:xfrm>
            <a:off x="6523463" y="4505507"/>
            <a:ext cx="47160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/>
              <a:t>G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FB22885-CC19-F549-A4B0-6E5EC4A87F3F}"/>
              </a:ext>
            </a:extLst>
          </p:cNvPr>
          <p:cNvSpPr txBox="1"/>
          <p:nvPr/>
        </p:nvSpPr>
        <p:spPr>
          <a:xfrm>
            <a:off x="7496987" y="4505506"/>
            <a:ext cx="5277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/>
              <a:t>W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4B7E2F5-E6CF-B848-818B-FF28AC9915FA}"/>
              </a:ext>
            </a:extLst>
          </p:cNvPr>
          <p:cNvSpPr txBox="1"/>
          <p:nvPr/>
        </p:nvSpPr>
        <p:spPr>
          <a:xfrm rot="16200000">
            <a:off x="2966339" y="3121573"/>
            <a:ext cx="1317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/>
              <a:t>∆S</a:t>
            </a:r>
            <a:r>
              <a:rPr lang="en-US" b="1" i="1" baseline="-25000" dirty="0"/>
              <a:t>dOHb</a:t>
            </a:r>
            <a:r>
              <a:rPr lang="en-US" b="1" i="1" dirty="0"/>
              <a:t>/∆S</a:t>
            </a:r>
            <a:r>
              <a:rPr lang="en-US" b="1" i="1" baseline="-25000" dirty="0"/>
              <a:t>Gd</a:t>
            </a:r>
            <a:endParaRPr lang="en-US" b="1" i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689D39-3F64-C743-8E52-E6FFEB9406B8}"/>
              </a:ext>
            </a:extLst>
          </p:cNvPr>
          <p:cNvSpPr txBox="1"/>
          <p:nvPr/>
        </p:nvSpPr>
        <p:spPr>
          <a:xfrm>
            <a:off x="9856506" y="15641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15021362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2" name="Table 2">
                <a:extLst>
                  <a:ext uri="{FF2B5EF4-FFF2-40B4-BE49-F238E27FC236}">
                    <a16:creationId xmlns:a16="http://schemas.microsoft.com/office/drawing/2014/main" id="{6A1DC867-C844-504C-9DEC-5EE55078B5B5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0" y="0"/>
              <a:ext cx="12192000" cy="6858000"/>
            </p:xfrm>
            <a:graphic>
              <a:graphicData uri="http://schemas.openxmlformats.org/drawingml/2006/table">
                <a:tbl>
                  <a:tblPr>
                    <a:tableStyleId>{073A0DAA-6AF3-43AB-8588-CEC1D06C72B9}</a:tableStyleId>
                  </a:tblPr>
                  <a:tblGrid>
                    <a:gridCol w="3122001">
                      <a:extLst>
                        <a:ext uri="{9D8B030D-6E8A-4147-A177-3AD203B41FA5}">
                          <a16:colId xmlns:a16="http://schemas.microsoft.com/office/drawing/2014/main" val="2550035014"/>
                        </a:ext>
                      </a:extLst>
                    </a:gridCol>
                    <a:gridCol w="5067842">
                      <a:extLst>
                        <a:ext uri="{9D8B030D-6E8A-4147-A177-3AD203B41FA5}">
                          <a16:colId xmlns:a16="http://schemas.microsoft.com/office/drawing/2014/main" val="2346176818"/>
                        </a:ext>
                      </a:extLst>
                    </a:gridCol>
                    <a:gridCol w="4002157">
                      <a:extLst>
                        <a:ext uri="{9D8B030D-6E8A-4147-A177-3AD203B41FA5}">
                          <a16:colId xmlns:a16="http://schemas.microsoft.com/office/drawing/2014/main" val="1338180096"/>
                        </a:ext>
                      </a:extLst>
                    </a:gridCol>
                  </a:tblGrid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n>
                                <a:noFill/>
                              </a:ln>
                              <a:solidFill>
                                <a:sysClr val="windowText" lastClr="000000"/>
                              </a:solidFill>
                            </a:rPr>
                            <a:t>Parameter [unit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lnTlToBr w="12700" cmpd="sng">
                          <a:noFill/>
                          <a:prstDash val="solid"/>
                        </a:lnTlToBr>
                        <a:lnBlToTr w="12700" cmpd="sng">
                          <a:noFill/>
                          <a:prstDash val="solid"/>
                        </a:lnBlToTr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Parameter Descrip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Valu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84096798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1370248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sSubSup>
                                <m:sSubSupPr>
                                  <m:ctrlPr>
                                    <a:rPr lang="en-CA" sz="1800" i="1" kern="1200" smtClean="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</m:ctrlPr>
                                </m:sSubSupPr>
                                <m:e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𝑅</m:t>
                                  </m:r>
                                </m:e>
                                <m:sub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2</m:t>
                                  </m:r>
                                </m:sub>
                                <m:sup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∗</m:t>
                                  </m:r>
                                </m:sup>
                              </m:sSubSup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[s</a:t>
                          </a:r>
                          <a:r>
                            <a:rPr lang="en-CA" baseline="30000" dirty="0">
                              <a:effectLst/>
                            </a:rPr>
                            <a:t>-1</a:t>
                          </a:r>
                          <a:r>
                            <a:rPr lang="en-CA" baseline="0" dirty="0">
                              <a:effectLst/>
                            </a:rPr>
                            <a:t>]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xation Rat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79933325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𝛾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[MHz/T]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Gyromagnetic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2</a:t>
                          </a:r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𝜋</m:t>
                              </m:r>
                            </m:oMath>
                          </a14:m>
                          <a:r>
                            <a:rPr lang="en-US" dirty="0"/>
                            <a:t>*42.6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408616074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B</a:t>
                          </a:r>
                          <a:r>
                            <a:rPr lang="en-US" i="1" baseline="-25000" dirty="0"/>
                            <a:t>0 </a:t>
                          </a:r>
                          <a:r>
                            <a:rPr lang="en-US" i="0" baseline="0" dirty="0"/>
                            <a:t>[T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agnetic Field Strength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.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40030607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TE </a:t>
                          </a:r>
                          <a:r>
                            <a:rPr lang="en-US" i="0" dirty="0"/>
                            <a:t>[m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Echo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198005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Hc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Frac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0.4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153848451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∆</m:t>
                              </m:r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𝑣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[MHz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Water Proton Frequency Shif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762900446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V </a:t>
                          </a:r>
                          <a:r>
                            <a:rPr lang="en-US" i="0" dirty="0"/>
                            <a:t>[mL/100g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Relative Cerebral Blood Volu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884720671"/>
                      </a:ext>
                    </a:extLst>
                  </a:tr>
                  <a:tr h="608622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𝜅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Correction Facto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0" dirty="0"/>
                            <a:t>dOHb</a:t>
                          </a:r>
                          <a:r>
                            <a:rPr lang="en-US" i="1" dirty="0"/>
                            <a:t> </a:t>
                          </a:r>
                          <a:r>
                            <a:rPr lang="en-US" i="1" dirty="0">
                              <a:sym typeface="Wingdings" pitchFamily="2" charset="2"/>
                            </a:rPr>
                            <a:t> </a:t>
                          </a:r>
                          <a14:m>
                            <m:oMath xmlns:m="http://schemas.openxmlformats.org/officeDocument/2006/math"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(1−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𝐻𝑐𝑡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)/(1−0.69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𝐻𝑐𝑡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)</m:t>
                              </m:r>
                            </m:oMath>
                          </a14:m>
                          <a:r>
                            <a:rPr lang="en-CA" sz="1800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 </a:t>
                          </a:r>
                          <a:endParaRPr lang="en-US" i="1" dirty="0">
                            <a:sym typeface="Wingdings" pitchFamily="2" charset="2"/>
                          </a:endParaRPr>
                        </a:p>
                        <a:p>
                          <a:pPr algn="ctr"/>
                          <a:r>
                            <a:rPr lang="en-US" i="0" dirty="0">
                              <a:sym typeface="Wingdings" pitchFamily="2" charset="2"/>
                            </a:rPr>
                            <a:t>Gd</a:t>
                          </a:r>
                          <a:r>
                            <a:rPr lang="en-US" i="1" dirty="0">
                              <a:sym typeface="Wingdings" pitchFamily="2" charset="2"/>
                            </a:rPr>
                            <a:t>  </a:t>
                          </a:r>
                          <a:r>
                            <a:rPr lang="en-CA" sz="1800" i="1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Hct</a:t>
                          </a:r>
                          <a:r>
                            <a:rPr lang="en-CA" sz="1800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/0.69</a:t>
                          </a:r>
                          <a:r>
                            <a:rPr lang="en-CA" sz="1800" i="1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Hct</a:t>
                          </a:r>
                          <a:r>
                            <a:rPr lang="en-CA" dirty="0">
                              <a:effectLst/>
                            </a:rPr>
                            <a:t> 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98407157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𝜌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 [g/mL]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Brain Density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0" dirty="0"/>
                            <a:t>1.05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977203812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F </a:t>
                          </a:r>
                          <a:r>
                            <a:rPr lang="en-US" i="0" dirty="0"/>
                            <a:t>[mL/100g/min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tive Cerebral Blood Flow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28708415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MTT </a:t>
                          </a:r>
                          <a:r>
                            <a:rPr lang="en-US" i="0" dirty="0"/>
                            <a:t>[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ean Transit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834513893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 </a:t>
                          </a:r>
                          <a:r>
                            <a:rPr lang="en-US" i="0" dirty="0"/>
                            <a:t>[%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Percentage Signal Chang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194027380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N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 to Noise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47529730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sSub>
                                <m:sSubPr>
                                  <m:ctrlPr>
                                    <a:rPr lang="en-CA" sz="1800" i="1" kern="1200" smtClean="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</m:ctrlPr>
                                </m:sSubPr>
                                <m:e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𝜀</m:t>
                                  </m:r>
                                </m:e>
                                <m:sub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𝑡</m:t>
                                  </m:r>
                                </m:sub>
                              </m:sSub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Standard Deviation of 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17443409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Percent Change in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264544899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i="1" dirty="0"/>
                            <a:t>Base-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Baseline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612153967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2" name="Table 2">
                <a:extLst>
                  <a:ext uri="{FF2B5EF4-FFF2-40B4-BE49-F238E27FC236}">
                    <a16:creationId xmlns:a16="http://schemas.microsoft.com/office/drawing/2014/main" id="{6A1DC867-C844-504C-9DEC-5EE55078B5B5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381938723"/>
                  </p:ext>
                </p:extLst>
              </p:nvPr>
            </p:nvGraphicFramePr>
            <p:xfrm>
              <a:off x="0" y="0"/>
              <a:ext cx="12192000" cy="6858000"/>
            </p:xfrm>
            <a:graphic>
              <a:graphicData uri="http://schemas.openxmlformats.org/drawingml/2006/table">
                <a:tbl>
                  <a:tblPr>
                    <a:tableStyleId>{073A0DAA-6AF3-43AB-8588-CEC1D06C72B9}</a:tableStyleId>
                  </a:tblPr>
                  <a:tblGrid>
                    <a:gridCol w="3122001">
                      <a:extLst>
                        <a:ext uri="{9D8B030D-6E8A-4147-A177-3AD203B41FA5}">
                          <a16:colId xmlns:a16="http://schemas.microsoft.com/office/drawing/2014/main" val="2550035014"/>
                        </a:ext>
                      </a:extLst>
                    </a:gridCol>
                    <a:gridCol w="5067842">
                      <a:extLst>
                        <a:ext uri="{9D8B030D-6E8A-4147-A177-3AD203B41FA5}">
                          <a16:colId xmlns:a16="http://schemas.microsoft.com/office/drawing/2014/main" val="2346176818"/>
                        </a:ext>
                      </a:extLst>
                    </a:gridCol>
                    <a:gridCol w="4002157">
                      <a:extLst>
                        <a:ext uri="{9D8B030D-6E8A-4147-A177-3AD203B41FA5}">
                          <a16:colId xmlns:a16="http://schemas.microsoft.com/office/drawing/2014/main" val="1338180096"/>
                        </a:ext>
                      </a:extLst>
                    </a:gridCol>
                  </a:tblGrid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n>
                                <a:noFill/>
                              </a:ln>
                              <a:solidFill>
                                <a:sysClr val="windowText" lastClr="000000"/>
                              </a:solidFill>
                            </a:rPr>
                            <a:t>Parameter [unit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lnTlToBr w="12700" cmpd="sng">
                          <a:noFill/>
                          <a:prstDash val="solid"/>
                        </a:lnTlToBr>
                        <a:lnBlToTr w="12700" cmpd="sng">
                          <a:noFill/>
                          <a:prstDash val="solid"/>
                        </a:lnBlToTr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Parameter Descrip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Valu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84096798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1370248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214286" r="-291057" b="-1653571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xation Rat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79933325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303448" r="-291057" b="-149655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Gyromagnetic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205079" t="-303448" r="-635" b="-1496552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408616074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B</a:t>
                          </a:r>
                          <a:r>
                            <a:rPr lang="en-US" i="1" baseline="-25000" dirty="0"/>
                            <a:t>0 </a:t>
                          </a:r>
                          <a:r>
                            <a:rPr lang="en-US" i="0" baseline="0" dirty="0"/>
                            <a:t>[T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agnetic Field Strength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.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40030607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TE </a:t>
                          </a:r>
                          <a:r>
                            <a:rPr lang="en-US" i="0" dirty="0"/>
                            <a:t>[m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Echo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198005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Hc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Frac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0.4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153848451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728571" r="-291057" b="-1139286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Water Proton Frequency Shif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762900446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V </a:t>
                          </a:r>
                          <a:r>
                            <a:rPr lang="en-US" i="0" dirty="0"/>
                            <a:t>[mL/100g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Relative Cerebral Blood Volu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884720671"/>
                      </a:ext>
                    </a:extLst>
                  </a:tr>
                  <a:tr h="64008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511765" r="-291057" b="-468627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Correction Facto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205079" t="-511765" r="-635" b="-468627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398407157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1114286" r="-291057" b="-753571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Brain Density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0" dirty="0"/>
                            <a:t>1.05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977203812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F </a:t>
                          </a:r>
                          <a:r>
                            <a:rPr lang="en-US" i="0" dirty="0"/>
                            <a:t>[mL/100g/min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tive Cerebral Blood Flow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28708415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MTT </a:t>
                          </a:r>
                          <a:r>
                            <a:rPr lang="en-US" i="0" dirty="0"/>
                            <a:t>[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ean Transit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834513893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 </a:t>
                          </a:r>
                          <a:r>
                            <a:rPr lang="en-US" i="0" dirty="0"/>
                            <a:t>[%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Percentage Signal Chang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194027380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N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 to Noise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47529730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1628571" r="-291057" b="-239286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Standard Deviation of 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17443409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Percent Change in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264544899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i="1" dirty="0"/>
                            <a:t>Base-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Baseline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612153967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4" name="TextBox 3">
            <a:extLst>
              <a:ext uri="{FF2B5EF4-FFF2-40B4-BE49-F238E27FC236}">
                <a16:creationId xmlns:a16="http://schemas.microsoft.com/office/drawing/2014/main" id="{B87E965B-98CA-0F47-B339-27AE889DD512}"/>
              </a:ext>
            </a:extLst>
          </p:cNvPr>
          <p:cNvSpPr txBox="1"/>
          <p:nvPr/>
        </p:nvSpPr>
        <p:spPr>
          <a:xfrm>
            <a:off x="10073075" y="-369332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3685674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9</Words>
  <Application>Microsoft Macintosh PowerPoint</Application>
  <PresentationFormat>Widescreen</PresentationFormat>
  <Paragraphs>241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Cambria Math</vt:lpstr>
      <vt:lpstr>Palatino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ob Schulman</dc:creator>
  <cp:lastModifiedBy>Jacob Schulman</cp:lastModifiedBy>
  <cp:revision>1</cp:revision>
  <dcterms:created xsi:type="dcterms:W3CDTF">2022-04-05T16:07:42Z</dcterms:created>
  <dcterms:modified xsi:type="dcterms:W3CDTF">2022-04-05T16:08:40Z</dcterms:modified>
</cp:coreProperties>
</file>